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60" r:id="rId5"/>
    <p:sldId id="261" r:id="rId6"/>
    <p:sldId id="258" r:id="rId7"/>
    <p:sldId id="262" r:id="rId8"/>
    <p:sldId id="263" r:id="rId9"/>
    <p:sldId id="264" r:id="rId10"/>
    <p:sldId id="265" r:id="rId11"/>
    <p:sldId id="266" r:id="rId12"/>
    <p:sldId id="267" r:id="rId1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3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8248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8365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8245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8138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6644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1466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7120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3781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2990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7907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4791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D962A-E04C-477D-906E-D1E63704F86B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868CD-AF6B-4726-9436-4222EEFF19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7632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B8B4F8CB-3E4F-4726-8818-0CC4EC7EDD48}"/>
              </a:ext>
            </a:extLst>
          </p:cNvPr>
          <p:cNvGrpSpPr/>
          <p:nvPr/>
        </p:nvGrpSpPr>
        <p:grpSpPr>
          <a:xfrm>
            <a:off x="0" y="0"/>
            <a:ext cx="9144000" cy="6857999"/>
            <a:chOff x="0" y="0"/>
            <a:chExt cx="9144000" cy="6857999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B9ADA640-97D7-2245-DB27-544490AE25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7999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D0F080C-81BA-FA2F-DCCF-85C47B30227E}"/>
                </a:ext>
              </a:extLst>
            </p:cNvPr>
            <p:cNvSpPr txBox="1"/>
            <p:nvPr/>
          </p:nvSpPr>
          <p:spPr>
            <a:xfrm>
              <a:off x="2943188" y="304800"/>
              <a:ext cx="325762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oregional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2266549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918F49E8-824B-4547-8147-94EB6F3F3B32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A9106C77-6B4C-5CA0-64ED-8C9213EBD8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D948326-583F-CF91-7C55-88A5B0EA798C}"/>
                </a:ext>
              </a:extLst>
            </p:cNvPr>
            <p:cNvSpPr txBox="1"/>
            <p:nvPr/>
          </p:nvSpPr>
          <p:spPr>
            <a:xfrm>
              <a:off x="3202073" y="285750"/>
              <a:ext cx="273985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240947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1ABBEBBD-5D34-4ADD-BCBF-9E82BE830C52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7C96430-02F5-D5E1-8666-B2941997BB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78CFC6B-F4B7-F8C1-6589-ABF8C2975E1D}"/>
                </a:ext>
              </a:extLst>
            </p:cNvPr>
            <p:cNvSpPr txBox="1"/>
            <p:nvPr/>
          </p:nvSpPr>
          <p:spPr>
            <a:xfrm>
              <a:off x="3202073" y="285750"/>
              <a:ext cx="273985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704964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3F53A307-9FD2-48B3-A47F-C3FBBD501B4F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9904CC7A-B7E2-5347-28DE-A5A5F1A81A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5E7D592-D378-81EB-AFB5-25140BDA1FC4}"/>
                </a:ext>
              </a:extLst>
            </p:cNvPr>
            <p:cNvSpPr txBox="1"/>
            <p:nvPr/>
          </p:nvSpPr>
          <p:spPr>
            <a:xfrm>
              <a:off x="3202073" y="285750"/>
              <a:ext cx="288091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47789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CFBE7652-A632-4AF8-9E83-12E1586AD20B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C9350E4-B170-87E7-06C1-B6944B1C02A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750885D-8D2F-D924-FCC0-2CBFA81E21B8}"/>
                </a:ext>
              </a:extLst>
            </p:cNvPr>
            <p:cNvSpPr txBox="1"/>
            <p:nvPr/>
          </p:nvSpPr>
          <p:spPr>
            <a:xfrm>
              <a:off x="2943188" y="304800"/>
              <a:ext cx="325762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oregional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991321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71A58673-7C0D-400D-89A3-5D0B8ACE5C04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6028F09B-3246-CC43-9920-60234DCE17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5336271-1328-B92A-491F-60BB0881798F}"/>
                </a:ext>
              </a:extLst>
            </p:cNvPr>
            <p:cNvSpPr txBox="1"/>
            <p:nvPr/>
          </p:nvSpPr>
          <p:spPr>
            <a:xfrm>
              <a:off x="2943188" y="304800"/>
              <a:ext cx="339868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oregional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06670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881AA0E7-BE14-41A5-98CD-99BD35DC9A77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DEB3B97-D71B-08A7-6EE0-56A58E0542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8E2F1F7-A96E-17C7-A7A8-48F1BFDB8F41}"/>
                </a:ext>
              </a:extLst>
            </p:cNvPr>
            <p:cNvSpPr txBox="1"/>
            <p:nvPr/>
          </p:nvSpPr>
          <p:spPr>
            <a:xfrm>
              <a:off x="2349276" y="314325"/>
              <a:ext cx="444544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t metastasis-free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83835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91EDE1B7-FFCF-41C4-87D1-73B23BDDA80D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69522DE-D5F9-963E-A34A-9027788F65C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3B1AA60-3F01-AF24-FD78-27F5803E8E1D}"/>
                </a:ext>
              </a:extLst>
            </p:cNvPr>
            <p:cNvSpPr txBox="1"/>
            <p:nvPr/>
          </p:nvSpPr>
          <p:spPr>
            <a:xfrm>
              <a:off x="2349276" y="333375"/>
              <a:ext cx="444544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t metastasis-free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27468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61D01E46-B530-4DE2-8FF8-92B2E6DF9D91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ED80EFCF-9A8F-3B0E-2C36-AE7EB25FAE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F64020F-773E-A287-C729-E34A8B052C64}"/>
                </a:ext>
              </a:extLst>
            </p:cNvPr>
            <p:cNvSpPr txBox="1"/>
            <p:nvPr/>
          </p:nvSpPr>
          <p:spPr>
            <a:xfrm>
              <a:off x="2239470" y="314325"/>
              <a:ext cx="466506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ant metastasis-free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852160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924B81F9-353D-4607-A766-570FD545B3D8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28696E27-E411-29B8-CB94-06B6EBBBE1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D42DFAA-710E-22F0-D04C-22D6C28E4C96}"/>
                </a:ext>
              </a:extLst>
            </p:cNvPr>
            <p:cNvSpPr txBox="1"/>
            <p:nvPr/>
          </p:nvSpPr>
          <p:spPr>
            <a:xfrm>
              <a:off x="2932769" y="314325"/>
              <a:ext cx="327846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-free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450202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2051B57D-E47F-47CE-A233-AFC41AFD8F8F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3B5A50D-D6DB-F30D-5033-E23C1AA6E9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7400C9E-0C42-E533-8828-5FEB99313409}"/>
                </a:ext>
              </a:extLst>
            </p:cNvPr>
            <p:cNvSpPr txBox="1"/>
            <p:nvPr/>
          </p:nvSpPr>
          <p:spPr>
            <a:xfrm>
              <a:off x="2932769" y="314325"/>
              <a:ext cx="327846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-free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718653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236C219B-459D-42E2-886D-186B360C2FFC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61F4F628-3C18-FF8F-345E-90DEC3A92C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8AFB0BC-5EA6-9EE5-0857-6F6FFD20DDB3}"/>
                </a:ext>
              </a:extLst>
            </p:cNvPr>
            <p:cNvSpPr txBox="1"/>
            <p:nvPr/>
          </p:nvSpPr>
          <p:spPr>
            <a:xfrm>
              <a:off x="2932769" y="314325"/>
              <a:ext cx="344357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-year</a:t>
              </a:r>
              <a:r>
                <a:rPr lang="ko-KR" altLang="en-US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ease-free survival</a:t>
              </a:r>
              <a:endParaRPr lang="ko-KR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32238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1</TotalTime>
  <Words>39</Words>
  <Application>Microsoft Office PowerPoint</Application>
  <PresentationFormat>화면 슬라이드 쇼(4:3)</PresentationFormat>
  <Paragraphs>12</Paragraphs>
  <Slides>1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1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hyun Bae</dc:creator>
  <cp:lastModifiedBy>Administrator</cp:lastModifiedBy>
  <cp:revision>2</cp:revision>
  <dcterms:created xsi:type="dcterms:W3CDTF">2024-01-01T16:38:23Z</dcterms:created>
  <dcterms:modified xsi:type="dcterms:W3CDTF">2024-04-18T08:02:42Z</dcterms:modified>
</cp:coreProperties>
</file>